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94" userDrawn="1">
          <p15:clr>
            <a:srgbClr val="A4A3A4"/>
          </p15:clr>
        </p15:guide>
        <p15:guide id="2" pos="2319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7EE6F6B-09A6-0A8A-8AA0-C5F42791E4AE}" name="xcvbn134" initials="x" userId="S::xcvbn134@mso365.tw::45a5483b-d5a8-4c4d-bff1-ed4d03ab0946" providerId="AD"/>
  <p188:author id="{0B93739B-17B6-7C84-AD9E-E55E29A8B1AF}" name="郑 礼军" initials="郑" userId="27df83b8c3c91c09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梁 普平" initials="梁" lastIdx="9" clrIdx="0">
    <p:extLst>
      <p:ext uri="{19B8F6BF-5375-455C-9EA6-DF929625EA0E}">
        <p15:presenceInfo xmlns:p15="http://schemas.microsoft.com/office/powerpoint/2012/main" userId="746b707f5a3c74e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36" autoAdjust="0"/>
    <p:restoredTop sz="94700"/>
  </p:normalViewPr>
  <p:slideViewPr>
    <p:cSldViewPr snapToGrid="0" snapToObjects="1">
      <p:cViewPr varScale="1">
        <p:scale>
          <a:sx n="41" d="100"/>
          <a:sy n="41" d="100"/>
        </p:scale>
        <p:origin x="2514" y="45"/>
      </p:cViewPr>
      <p:guideLst>
        <p:guide orient="horz" pos="2394"/>
        <p:guide pos="2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96507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9234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514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061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7391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71142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672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4842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36986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079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86838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2EA85-73B3-F04F-9D21-E14BDA68261E}" type="datetimeFigureOut">
              <a:rPr kumimoji="1" lang="zh-CN" altLang="en-US" smtClean="0"/>
              <a:t>2023/12/5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841BBE-2B35-7343-8877-EB9AA5EC4D8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19647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DBE17DD-1DF0-F5CD-1BD2-FB2126D56193}"/>
              </a:ext>
            </a:extLst>
          </p:cNvPr>
          <p:cNvSpPr txBox="1"/>
          <p:nvPr/>
        </p:nvSpPr>
        <p:spPr>
          <a:xfrm>
            <a:off x="0" y="0"/>
            <a:ext cx="2485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 descr="图片包含 文本&#10;&#10;描述已自动生成">
            <a:extLst>
              <a:ext uri="{FF2B5EF4-FFF2-40B4-BE49-F238E27FC236}">
                <a16:creationId xmlns:a16="http://schemas.microsoft.com/office/drawing/2014/main" id="{0B7BCABF-CCD3-0A29-02CB-2B27341CCE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7548" y="2505629"/>
            <a:ext cx="1708407" cy="274320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E2AEADF-1FAE-502C-882E-807A934F0474}"/>
              </a:ext>
            </a:extLst>
          </p:cNvPr>
          <p:cNvSpPr txBox="1"/>
          <p:nvPr/>
        </p:nvSpPr>
        <p:spPr>
          <a:xfrm>
            <a:off x="207564" y="8809782"/>
            <a:ext cx="656837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Agarose gel analysis of LAMP product from Orf1ab LAMP amplification. N: Negative control; P: </a:t>
            </a:r>
            <a:r>
              <a:rPr kumimoji="1"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ositive amplicon.</a:t>
            </a:r>
            <a:endParaRPr kumimoji="1"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1544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87</TotalTime>
  <Words>28</Words>
  <Application>Microsoft Office PowerPoint</Application>
  <PresentationFormat>A4 纸张(210x297 毫米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梁 普平</dc:creator>
  <cp:lastModifiedBy>vinson vic</cp:lastModifiedBy>
  <cp:revision>114</cp:revision>
  <dcterms:created xsi:type="dcterms:W3CDTF">2022-09-20T02:05:32Z</dcterms:created>
  <dcterms:modified xsi:type="dcterms:W3CDTF">2023-12-05T10:17:24Z</dcterms:modified>
</cp:coreProperties>
</file>